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69A07-5D84-4C69-BDA4-71D52CA256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1BAA7-D9A1-445B-B618-E2998C16C8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4AE46-B2F6-413C-A13E-9EC2CC2908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68FDA-C00E-42B1-96CE-28E82C2111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C05BB-396C-48B1-B5E1-42D0BB59DE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F8AA4-F1B1-479A-A1E3-989CAAE90B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54D18-A8E7-420A-BAA9-E6713449C3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9F7EB-8512-46AB-8AF4-15D7A47C64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5A6B3-5646-44C9-9EC8-92C0E5D944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476D8-EDDC-4C2E-A44C-D0CFE6035B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4974D-A12E-4281-87F3-7460E6AB00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5CE9A-AA09-4C45-B1F6-7D3E9AFEE9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87BA8B2-E819-4334-A67B-A25D130DD4F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27080" y="2075040"/>
          <a:ext cx="5376960" cy="1447560"/>
        </p:xfrm>
        <a:graphic>
          <a:graphicData uri="http://schemas.openxmlformats.org/drawingml/2006/table">
            <a:tbl>
              <a:tblPr/>
              <a:tblGrid>
                <a:gridCol w="339480"/>
                <a:gridCol w="911520"/>
                <a:gridCol w="749160"/>
                <a:gridCol w="760320"/>
                <a:gridCol w="782640"/>
                <a:gridCol w="819360"/>
                <a:gridCol w="817560"/>
                <a:gridCol w="196920"/>
              </a:tblGrid>
              <a:tr h="439560">
                <a:tc gridSpan="8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mparison of means of FOXA1 expression between BRCA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d BRCA2/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30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oup Statistic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06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_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Devi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54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9801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594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9078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th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.7704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0508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2748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08000" y="4075200"/>
          <a:ext cx="6467400" cy="2874960"/>
        </p:xfrm>
        <a:graphic>
          <a:graphicData uri="http://schemas.openxmlformats.org/drawingml/2006/table">
            <a:tbl>
              <a:tblPr/>
              <a:tblGrid>
                <a:gridCol w="739800"/>
                <a:gridCol w="563400"/>
                <a:gridCol w="488880"/>
                <a:gridCol w="471600"/>
                <a:gridCol w="534960"/>
                <a:gridCol w="550800"/>
                <a:gridCol w="606600"/>
                <a:gridCol w="635040"/>
                <a:gridCol w="649080"/>
                <a:gridCol w="662040"/>
                <a:gridCol w="565200"/>
              </a:tblGrid>
              <a:tr h="219600">
                <a:tc gridSpan="11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ependent Samples Tes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6480">
                <a:tc gridSpan="2" rowSpan="3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vene's Test for Equality of Varia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7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test for Equality of Mea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9176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 of the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4956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w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p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8880"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express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1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7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2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0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not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1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.5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7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.3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74240"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160" rIns="11160" tIns="11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1160" marR="111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3"/>
          <p:cNvSpPr/>
          <p:nvPr/>
        </p:nvSpPr>
        <p:spPr>
          <a:xfrm>
            <a:off x="5081040" y="9609120"/>
            <a:ext cx="187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10-01T11:15:00Z</dcterms:modified>
  <cp:revision>591</cp:revision>
  <dc:subject/>
  <dc:title>PowerPoint Presentation</dc:title>
</cp:coreProperties>
</file>